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86BC3-AECD-4427-8343-915FC2034B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2E83B-0E2B-4A9A-8F9D-7A82B84F73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E32A6-AB9A-43F8-9CB7-7FAA1945C1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121AC8-77C9-4C11-8FB5-9823FDE632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C6F0F-47B6-4BE1-99D1-559143A6FE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CB4E0-8102-4D93-9D30-8F41FAEFFE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BCDFD-D59E-4579-8F56-EF5E4499FF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1057C-AE44-4555-AD76-33A6DF420A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4F0AB-8DC2-4EC9-AC0E-7525CE0A48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D222B-63BF-4FD5-9F66-53839BA6A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D94BC-D82F-4B83-8091-AA0A58CDA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9C4B8-D303-4FAE-A1B2-FB5CCF3F0F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7D7641-9E8B-47B8-ADBE-88E9E8CCC3C2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294840" y="-4680"/>
            <a:ext cx="233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ABLE S2. List of Prim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1751040" y="396720"/>
            <a:ext cx="57780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3040200" y="396720"/>
            <a:ext cx="184464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(5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→ 3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"/>
          <p:cNvSpPr/>
          <p:nvPr/>
        </p:nvSpPr>
        <p:spPr>
          <a:xfrm>
            <a:off x="571680" y="37944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6"/>
          <p:cNvSpPr/>
          <p:nvPr/>
        </p:nvSpPr>
        <p:spPr>
          <a:xfrm>
            <a:off x="571680" y="57960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7"/>
          <p:cNvSpPr/>
          <p:nvPr/>
        </p:nvSpPr>
        <p:spPr>
          <a:xfrm>
            <a:off x="571680" y="860256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6"/>
          <p:cNvSpPr/>
          <p:nvPr/>
        </p:nvSpPr>
        <p:spPr>
          <a:xfrm>
            <a:off x="853560" y="8602560"/>
            <a:ext cx="518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derlined letters indicate restriction sites used for subcloning. Mutagenized nucleotides are bol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7"/>
          <p:cNvSpPr/>
          <p:nvPr/>
        </p:nvSpPr>
        <p:spPr>
          <a:xfrm>
            <a:off x="806400" y="600120"/>
            <a:ext cx="406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B1 promoter deletion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9"/>
          <p:cNvSpPr/>
          <p:nvPr/>
        </p:nvSpPr>
        <p:spPr>
          <a:xfrm>
            <a:off x="806400" y="2252520"/>
            <a:ext cx="406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B1 promoter excision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0"/>
          <p:cNvSpPr/>
          <p:nvPr/>
        </p:nvSpPr>
        <p:spPr>
          <a:xfrm>
            <a:off x="831240" y="5245200"/>
            <a:ext cx="583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B1 promoter mutation constructs (pBmEcR-B1_mu01 to _mu10)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1"/>
          <p:cNvSpPr/>
          <p:nvPr/>
        </p:nvSpPr>
        <p:spPr>
          <a:xfrm>
            <a:off x="1293120" y="822240"/>
            <a:ext cx="452412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3652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AATTAACAGTCAGA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300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AGTGGTAAACCGAA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290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TGCATGACGGATTTGG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280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CAATGTTCACAGGC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270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CACACGCGAAAACTAG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260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AATCTTATATTACCTTCAA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2527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ATTTCGCCTGTATTT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-200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ACTGACAGATAATTACGAAA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+248_A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Nco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G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AT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CACTCGTCAGCGCG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2"/>
          <p:cNvSpPr/>
          <p:nvPr/>
        </p:nvSpPr>
        <p:spPr>
          <a:xfrm>
            <a:off x="1271880" y="2436840"/>
            <a:ext cx="3990600" cy="283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2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AACTATGATATCGCGTAG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2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GCGTTTAAGAAATGTCAC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3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GGAAATAAATAATTTATTATT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3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TTGTTTTTTTTTTTTTAAT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4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TATCTGCACATAGTGTAGTG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4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GTGGCTTTGTGCTGT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5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CCAAATCCGTCATG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5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ACGCTCCGCGA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6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CTGCCAATGTTTTGGAA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6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CAATGTTCACAGGC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8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TTGGAAATACACAGCA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8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ACGCTCCGCGA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09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AGAACACGTGATGCTG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10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GAGCGTTGACCTG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10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ATGCTGTGACGCGAAC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11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TGTTCTCGCGGAG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1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CGAACTTAGCAATGT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ex12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AGCATCACGTGTTCT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63"/>
          <p:cNvSpPr/>
          <p:nvPr/>
        </p:nvSpPr>
        <p:spPr>
          <a:xfrm>
            <a:off x="1271520" y="5435640"/>
            <a:ext cx="3686040" cy="31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1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GGAAATACACAGCACAAA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GGTCAACGC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2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T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AATGTTTT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2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TCCGCGAGAAC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3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CCAATGTTTTGGAAATAC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3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CCGCGA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4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T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TTGACCT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4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ACACGTGATGCTGTG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5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GACCTGCCAATGTTT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5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TC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ACGTG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6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GGAGCGTTGACC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6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ATGCTGTG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7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CTCGCGGAGCGTT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7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GTGACG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8_AS2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GTGTTCTCGCGGA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8_S2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CGAACTTA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9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T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AGCATC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09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AGCAATGTTCACAGGC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0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T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GTCACA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0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TGTTCACAGGCAACC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9T11:11:12Z</dcterms:created>
  <dc:creator>白井博之</dc:creator>
  <dc:description/>
  <dc:language>en-US</dc:language>
  <cp:lastModifiedBy> </cp:lastModifiedBy>
  <dcterms:modified xsi:type="dcterms:W3CDTF">2012-05-17T06:12:05Z</dcterms:modified>
  <cp:revision>22</cp:revision>
  <dc:subject/>
  <dc:title>スライド 1</dc:title>
</cp:coreProperties>
</file>